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-792" y="16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2682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875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5368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7352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6376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8760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1654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3814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2548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680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941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534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76672" y="3851920"/>
            <a:ext cx="590465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3: Figure S3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equence analysis of </a:t>
            </a:r>
            <a:r>
              <a:rPr lang="en-US" sz="1200" b="1" i="1" dirty="0">
                <a:latin typeface="Times New Roman" pitchFamily="18" charset="0"/>
                <a:cs typeface="Times New Roman" pitchFamily="18" charset="0"/>
              </a:rPr>
              <a:t>B. cereus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err="1">
                <a:latin typeface="Times New Roman" pitchFamily="18" charset="0"/>
                <a:cs typeface="Times New Roman" pitchFamily="18" charset="0"/>
              </a:rPr>
              <a:t>Fn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Sequence alignment was performed using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lustalW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software. Conserved residues are indicated by a star; conservatively substituted residues are indicated by a colon and semi-conservatively substituted residues are indicated by a point. The cysteine residues are indicated in bold. The cysteine residues 227, 230 and 235 that coordinate the [4Fe-4S]</a:t>
            </a:r>
            <a:r>
              <a:rPr lang="en-US" sz="1200" baseline="30000" dirty="0">
                <a:latin typeface="Times New Roman" pitchFamily="18" charset="0"/>
                <a:cs typeface="Times New Roman" pitchFamily="18" charset="0"/>
              </a:rPr>
              <a:t>2+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cluster with aspartate residue 141 in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subtili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re indicated in gray. 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100" y="1043608"/>
            <a:ext cx="5772150" cy="2344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27856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8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umr a408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duport</dc:creator>
  <cp:lastModifiedBy>cdomile</cp:lastModifiedBy>
  <cp:revision>12</cp:revision>
  <dcterms:created xsi:type="dcterms:W3CDTF">2011-11-21T15:19:55Z</dcterms:created>
  <dcterms:modified xsi:type="dcterms:W3CDTF">2012-11-27T07:08:30Z</dcterms:modified>
</cp:coreProperties>
</file>